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89317-DCC6-4844-A58F-6B41C4581D7D}" type="datetimeFigureOut">
              <a:rPr lang="fr-FR" smtClean="0"/>
              <a:pPr/>
              <a:t>08/02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DAB5-93E8-419A-A22A-9C40F6212691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107107" y="559713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S7 </a:t>
            </a:r>
            <a:r>
              <a:rPr lang="fr-FR" sz="1200" b="1" dirty="0" smtClean="0">
                <a:latin typeface="Times New Roman" pitchFamily="18" charset="0"/>
                <a:cs typeface="Times New Roman" pitchFamily="18" charset="0"/>
              </a:rPr>
              <a:t>|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Morphological analysis of labyrinthine area at 28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dpc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from first generation. </a:t>
            </a:r>
            <a:endParaRPr lang="fr-FR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" name="Tableau 6"/>
          <p:cNvGraphicFramePr>
            <a:graphicFrameLocks noGrp="1"/>
          </p:cNvGraphicFramePr>
          <p:nvPr/>
        </p:nvGraphicFramePr>
        <p:xfrm>
          <a:off x="107107" y="885217"/>
          <a:ext cx="6660000" cy="3335871"/>
        </p:xfrm>
        <a:graphic>
          <a:graphicData uri="http://schemas.openxmlformats.org/drawingml/2006/table">
            <a:tbl>
              <a:tblPr/>
              <a:tblGrid>
                <a:gridCol w="1085750"/>
                <a:gridCol w="360040"/>
                <a:gridCol w="360040"/>
                <a:gridCol w="1296144"/>
                <a:gridCol w="1512168"/>
                <a:gridCol w="432048"/>
                <a:gridCol w="936104"/>
                <a:gridCol w="677706"/>
              </a:tblGrid>
              <a:tr h="36932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Variabl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Numbe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of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fetuses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Median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[Q1; Q3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Adjusted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</a:t>
                      </a:r>
                      <a:r>
                        <a:rPr lang="fr-FR" sz="1000" b="1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linear</a:t>
                      </a:r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 model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47729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C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</a:t>
                      </a:r>
                      <a:endParaRPr lang="fr-FR" sz="10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l-GR" sz="10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β </a:t>
                      </a:r>
                      <a:r>
                        <a:rPr lang="fr-FR" sz="1000" b="1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alu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CI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1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p-valu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7692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Volume fraction of </a:t>
                      </a:r>
                      <a:r>
                        <a:rPr lang="fr-FR" sz="1000" b="0" i="0" u="none" strike="noStrike" dirty="0" err="1">
                          <a:solidFill>
                            <a:srgbClr val="000000"/>
                          </a:solidFill>
                          <a:latin typeface="Times New Roman"/>
                        </a:rPr>
                        <a:t>trophoblast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.78 [27.40; 45.64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01 [15.57; 28.7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12.795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[-22.192;-3.398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04**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3494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olume fraction of fetal capillaries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32.56 [28.28; 33.60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8.78 [15.39; 22.83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-10.73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[-16.733;-4.727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02**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77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Volume fraction of maternal blood spac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14 [15.91; 36.59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2.33 [47.88; 57.4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473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[16.86;36.086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001***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216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Volume fraction of circulating cells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2850 [0.0750; 0.782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340 [0.858; 1.883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14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[0.49;1.537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01**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949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rface density of trophoblast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970 [0.1550; 0.222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345 [0.1188; 0.1610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45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[-0.095;0.00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45*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3494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rface density of fetal capillaries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780 [0.1343; 0.1910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215 [0.1108; 0.1463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0.04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[-0.075;-0.00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14*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550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urface density of maternal blood space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120 [0.0910; 0.1468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1565 [0.1245; 0.164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033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[0.002;0.065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55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401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Surface density of circulating cells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018 [0.0007; 0.0056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103 [0.0075; 0.0136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.008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[0.004;0.012]</a:t>
                      </a: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0.001**</a:t>
                      </a:r>
                      <a:endParaRPr lang="fr-FR" sz="10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883" marR="7883" marT="788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107107" y="4226788"/>
            <a:ext cx="666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All data are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expressed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 as </a:t>
            </a:r>
            <a:r>
              <a:rPr lang="fr-FR" sz="1200" dirty="0" err="1" smtClean="0">
                <a:latin typeface="Times New Roman" pitchFamily="18" charset="0"/>
                <a:cs typeface="Times New Roman" pitchFamily="18" charset="0"/>
              </a:rPr>
              <a:t>median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[Q1;Q3]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3</TotalTime>
  <Words>250</Words>
  <Application>Microsoft Office PowerPoint</Application>
  <PresentationFormat>Affichage à l'écran (4:3)</PresentationFormat>
  <Paragraphs>7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N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valentino</dc:creator>
  <cp:lastModifiedBy>Sarah</cp:lastModifiedBy>
  <cp:revision>50</cp:revision>
  <dcterms:created xsi:type="dcterms:W3CDTF">2015-02-24T15:36:47Z</dcterms:created>
  <dcterms:modified xsi:type="dcterms:W3CDTF">2016-02-08T10:30:46Z</dcterms:modified>
</cp:coreProperties>
</file>